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custDataLst>
    <p:tags r:id="rId3"/>
  </p:custDataLst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938EC25-FD14-40D0-916E-68DAA43B0978}" v="10" dt="2025-09-12T11:19:23.39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32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DE LOS ANGELES MORON ORTIZ" userId="d41356f5-171a-45c7-ae78-b03c758bffd3" providerId="ADAL" clId="{74E63C05-30DE-419B-BDBB-02E851870319}"/>
    <pc:docChg chg="undo custSel modSld">
      <pc:chgData name="MARIA DE LOS ANGELES MORON ORTIZ" userId="d41356f5-171a-45c7-ae78-b03c758bffd3" providerId="ADAL" clId="{74E63C05-30DE-419B-BDBB-02E851870319}" dt="2025-09-12T11:19:23.396" v="66" actId="164"/>
      <pc:docMkLst>
        <pc:docMk/>
      </pc:docMkLst>
      <pc:sldChg chg="addSp delSp modSp mod">
        <pc:chgData name="MARIA DE LOS ANGELES MORON ORTIZ" userId="d41356f5-171a-45c7-ae78-b03c758bffd3" providerId="ADAL" clId="{74E63C05-30DE-419B-BDBB-02E851870319}" dt="2025-09-12T11:19:23.396" v="66" actId="164"/>
        <pc:sldMkLst>
          <pc:docMk/>
          <pc:sldMk cId="3140822888" sldId="256"/>
        </pc:sldMkLst>
        <pc:spChg chg="add mod topLvl">
          <ac:chgData name="MARIA DE LOS ANGELES MORON ORTIZ" userId="d41356f5-171a-45c7-ae78-b03c758bffd3" providerId="ADAL" clId="{74E63C05-30DE-419B-BDBB-02E851870319}" dt="2025-09-12T11:18:39.525" v="52" actId="164"/>
          <ac:spMkLst>
            <pc:docMk/>
            <pc:sldMk cId="3140822888" sldId="256"/>
            <ac:spMk id="2" creationId="{C7EC980F-CC67-9CD5-D31C-808D7B55CFD1}"/>
          </ac:spMkLst>
        </pc:spChg>
        <pc:spChg chg="add del">
          <ac:chgData name="MARIA DE LOS ANGELES MORON ORTIZ" userId="d41356f5-171a-45c7-ae78-b03c758bffd3" providerId="ADAL" clId="{74E63C05-30DE-419B-BDBB-02E851870319}" dt="2025-09-12T11:17:10.995" v="14" actId="22"/>
          <ac:spMkLst>
            <pc:docMk/>
            <pc:sldMk cId="3140822888" sldId="256"/>
            <ac:spMk id="4" creationId="{5B7D6B42-8635-C418-68B1-986FDAF7B2AC}"/>
          </ac:spMkLst>
        </pc:spChg>
        <pc:spChg chg="add mod topLvl">
          <ac:chgData name="MARIA DE LOS ANGELES MORON ORTIZ" userId="d41356f5-171a-45c7-ae78-b03c758bffd3" providerId="ADAL" clId="{74E63C05-30DE-419B-BDBB-02E851870319}" dt="2025-09-12T11:18:39.525" v="52" actId="164"/>
          <ac:spMkLst>
            <pc:docMk/>
            <pc:sldMk cId="3140822888" sldId="256"/>
            <ac:spMk id="5" creationId="{4BE00306-1855-5545-15AC-A42079FF5C69}"/>
          </ac:spMkLst>
        </pc:spChg>
        <pc:spChg chg="mod">
          <ac:chgData name="MARIA DE LOS ANGELES MORON ORTIZ" userId="d41356f5-171a-45c7-ae78-b03c758bffd3" providerId="ADAL" clId="{74E63C05-30DE-419B-BDBB-02E851870319}" dt="2025-09-12T11:18:36.197" v="51" actId="165"/>
          <ac:spMkLst>
            <pc:docMk/>
            <pc:sldMk cId="3140822888" sldId="256"/>
            <ac:spMk id="7" creationId="{7F96EF50-A64B-5BF9-D406-977DA2D8842C}"/>
          </ac:spMkLst>
        </pc:spChg>
        <pc:spChg chg="mod">
          <ac:chgData name="MARIA DE LOS ANGELES MORON ORTIZ" userId="d41356f5-171a-45c7-ae78-b03c758bffd3" providerId="ADAL" clId="{74E63C05-30DE-419B-BDBB-02E851870319}" dt="2025-09-12T11:18:36.197" v="51" actId="165"/>
          <ac:spMkLst>
            <pc:docMk/>
            <pc:sldMk cId="3140822888" sldId="256"/>
            <ac:spMk id="8" creationId="{F3BBBBB1-6C7C-7671-B09E-CEA1F3D13E99}"/>
          </ac:spMkLst>
        </pc:spChg>
        <pc:spChg chg="mod">
          <ac:chgData name="MARIA DE LOS ANGELES MORON ORTIZ" userId="d41356f5-171a-45c7-ae78-b03c758bffd3" providerId="ADAL" clId="{74E63C05-30DE-419B-BDBB-02E851870319}" dt="2025-09-12T11:18:11.438" v="46"/>
          <ac:spMkLst>
            <pc:docMk/>
            <pc:sldMk cId="3140822888" sldId="256"/>
            <ac:spMk id="14" creationId="{807567A1-E2E3-E4A2-48A3-238A0E2C8140}"/>
          </ac:spMkLst>
        </pc:spChg>
        <pc:spChg chg="mod">
          <ac:chgData name="MARIA DE LOS ANGELES MORON ORTIZ" userId="d41356f5-171a-45c7-ae78-b03c758bffd3" providerId="ADAL" clId="{74E63C05-30DE-419B-BDBB-02E851870319}" dt="2025-09-12T11:18:11.438" v="46"/>
          <ac:spMkLst>
            <pc:docMk/>
            <pc:sldMk cId="3140822888" sldId="256"/>
            <ac:spMk id="15" creationId="{C7F3D74A-568B-CF25-7185-00566D297793}"/>
          </ac:spMkLst>
        </pc:spChg>
        <pc:spChg chg="add mod">
          <ac:chgData name="MARIA DE LOS ANGELES MORON ORTIZ" userId="d41356f5-171a-45c7-ae78-b03c758bffd3" providerId="ADAL" clId="{74E63C05-30DE-419B-BDBB-02E851870319}" dt="2025-09-12T11:18:11.438" v="46"/>
          <ac:spMkLst>
            <pc:docMk/>
            <pc:sldMk cId="3140822888" sldId="256"/>
            <ac:spMk id="16" creationId="{DCC535CD-D8B0-BB54-C1F7-CC6B37A452FD}"/>
          </ac:spMkLst>
        </pc:spChg>
        <pc:spChg chg="add mod">
          <ac:chgData name="MARIA DE LOS ANGELES MORON ORTIZ" userId="d41356f5-171a-45c7-ae78-b03c758bffd3" providerId="ADAL" clId="{74E63C05-30DE-419B-BDBB-02E851870319}" dt="2025-09-12T11:18:11.438" v="46"/>
          <ac:spMkLst>
            <pc:docMk/>
            <pc:sldMk cId="3140822888" sldId="256"/>
            <ac:spMk id="17" creationId="{D36C6A92-0073-AA85-E5B8-2D56B279AC1E}"/>
          </ac:spMkLst>
        </pc:spChg>
        <pc:spChg chg="add del mod">
          <ac:chgData name="MARIA DE LOS ANGELES MORON ORTIZ" userId="d41356f5-171a-45c7-ae78-b03c758bffd3" providerId="ADAL" clId="{74E63C05-30DE-419B-BDBB-02E851870319}" dt="2025-09-12T11:18:53.460" v="57" actId="478"/>
          <ac:spMkLst>
            <pc:docMk/>
            <pc:sldMk cId="3140822888" sldId="256"/>
            <ac:spMk id="18" creationId="{5A94FD4E-5FD6-189A-2DA9-399784498358}"/>
          </ac:spMkLst>
        </pc:spChg>
        <pc:spChg chg="add mod">
          <ac:chgData name="MARIA DE LOS ANGELES MORON ORTIZ" userId="d41356f5-171a-45c7-ae78-b03c758bffd3" providerId="ADAL" clId="{74E63C05-30DE-419B-BDBB-02E851870319}" dt="2025-09-12T11:19:23.396" v="66" actId="164"/>
          <ac:spMkLst>
            <pc:docMk/>
            <pc:sldMk cId="3140822888" sldId="256"/>
            <ac:spMk id="20" creationId="{AF8B4C0A-B634-C13C-CF3C-F739721511F0}"/>
          </ac:spMkLst>
        </pc:spChg>
        <pc:spChg chg="add mod">
          <ac:chgData name="MARIA DE LOS ANGELES MORON ORTIZ" userId="d41356f5-171a-45c7-ae78-b03c758bffd3" providerId="ADAL" clId="{74E63C05-30DE-419B-BDBB-02E851870319}" dt="2025-09-12T11:19:23.396" v="66" actId="164"/>
          <ac:spMkLst>
            <pc:docMk/>
            <pc:sldMk cId="3140822888" sldId="256"/>
            <ac:spMk id="21" creationId="{FBF53919-BA01-BC9F-79EA-1192ED90D52C}"/>
          </ac:spMkLst>
        </pc:spChg>
        <pc:grpChg chg="mod topLvl">
          <ac:chgData name="MARIA DE LOS ANGELES MORON ORTIZ" userId="d41356f5-171a-45c7-ae78-b03c758bffd3" providerId="ADAL" clId="{74E63C05-30DE-419B-BDBB-02E851870319}" dt="2025-09-12T11:18:39.525" v="52" actId="164"/>
          <ac:grpSpMkLst>
            <pc:docMk/>
            <pc:sldMk cId="3140822888" sldId="256"/>
            <ac:grpSpMk id="9" creationId="{AEE46296-BEA7-D8EE-FFB9-D4B68A5F5894}"/>
          </ac:grpSpMkLst>
        </pc:grpChg>
        <pc:grpChg chg="add del mod">
          <ac:chgData name="MARIA DE LOS ANGELES MORON ORTIZ" userId="d41356f5-171a-45c7-ae78-b03c758bffd3" providerId="ADAL" clId="{74E63C05-30DE-419B-BDBB-02E851870319}" dt="2025-09-12T11:18:36.197" v="51" actId="165"/>
          <ac:grpSpMkLst>
            <pc:docMk/>
            <pc:sldMk cId="3140822888" sldId="256"/>
            <ac:grpSpMk id="10" creationId="{A8E00FEF-00EA-41D6-4CDD-17C64CD2CCC7}"/>
          </ac:grpSpMkLst>
        </pc:grpChg>
        <pc:grpChg chg="add mod">
          <ac:chgData name="MARIA DE LOS ANGELES MORON ORTIZ" userId="d41356f5-171a-45c7-ae78-b03c758bffd3" providerId="ADAL" clId="{74E63C05-30DE-419B-BDBB-02E851870319}" dt="2025-09-12T11:18:11.438" v="46"/>
          <ac:grpSpMkLst>
            <pc:docMk/>
            <pc:sldMk cId="3140822888" sldId="256"/>
            <ac:grpSpMk id="12" creationId="{4D29F837-E3A4-980E-88A1-051B3F117A9E}"/>
          </ac:grpSpMkLst>
        </pc:grpChg>
        <pc:grpChg chg="add mod">
          <ac:chgData name="MARIA DE LOS ANGELES MORON ORTIZ" userId="d41356f5-171a-45c7-ae78-b03c758bffd3" providerId="ADAL" clId="{74E63C05-30DE-419B-BDBB-02E851870319}" dt="2025-09-12T11:19:23.396" v="66" actId="164"/>
          <ac:grpSpMkLst>
            <pc:docMk/>
            <pc:sldMk cId="3140822888" sldId="256"/>
            <ac:grpSpMk id="19" creationId="{CCE51F26-A1B4-9B31-6AAE-DDA65765B890}"/>
          </ac:grpSpMkLst>
        </pc:grpChg>
        <pc:grpChg chg="add mod">
          <ac:chgData name="MARIA DE LOS ANGELES MORON ORTIZ" userId="d41356f5-171a-45c7-ae78-b03c758bffd3" providerId="ADAL" clId="{74E63C05-30DE-419B-BDBB-02E851870319}" dt="2025-09-12T11:19:23.396" v="66" actId="164"/>
          <ac:grpSpMkLst>
            <pc:docMk/>
            <pc:sldMk cId="3140822888" sldId="256"/>
            <ac:grpSpMk id="22" creationId="{C790DC2E-60F4-7E9B-2B8D-86D9093D750C}"/>
          </ac:grpSpMkLst>
        </pc:grpChg>
        <pc:picChg chg="mod">
          <ac:chgData name="MARIA DE LOS ANGELES MORON ORTIZ" userId="d41356f5-171a-45c7-ae78-b03c758bffd3" providerId="ADAL" clId="{74E63C05-30DE-419B-BDBB-02E851870319}" dt="2025-09-12T11:18:36.197" v="51" actId="165"/>
          <ac:picMkLst>
            <pc:docMk/>
            <pc:sldMk cId="3140822888" sldId="256"/>
            <ac:picMk id="6" creationId="{670477E8-2F73-86DA-5914-2AD49FE2139F}"/>
          </ac:picMkLst>
        </pc:picChg>
        <pc:picChg chg="mod">
          <ac:chgData name="MARIA DE LOS ANGELES MORON ORTIZ" userId="d41356f5-171a-45c7-ae78-b03c758bffd3" providerId="ADAL" clId="{74E63C05-30DE-419B-BDBB-02E851870319}" dt="2025-09-12T11:18:11.438" v="46"/>
          <ac:picMkLst>
            <pc:docMk/>
            <pc:sldMk cId="3140822888" sldId="256"/>
            <ac:picMk id="13" creationId="{73CF652E-605C-5EBA-8D23-D5FCA70A141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A2708A-0A8A-EF4D-0674-0C6E7D4191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AA8C724-783B-02BA-972B-9A9B6A048B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317D15D-2FF4-57F2-70AB-D94D03496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17EF2B7-30FD-843F-E073-D1F9889E6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43E318D-D8DF-22AA-3F5A-08952EA81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1558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24FEB85-F075-B29A-2A7B-2CCEB5C25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8E8BA00-8E12-4102-2210-2618299C09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5812548-18D8-EE1C-CDC6-3D6249BA4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438A2D6-A047-A969-A044-A0DA46E84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990BA1B-2390-1BBB-0EB3-0CDC184E3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9097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2A8DFEE-7BC0-62CF-8609-EE9DA779C5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A663F04-F595-0B56-0EA7-B0997F57C5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67AFB36-B1F4-3FE7-654D-71BBAD814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6D1FE2C-C796-7248-C1FE-243162F67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7B8B49D-6520-8E26-313D-D1C3166AF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6380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3F1BA5-0E21-A904-20CE-FC2BC744C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DA5CC1C-F935-B399-56CC-41247A0316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607292-A5A5-A82E-842F-0E302955E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C8A34E-FBD5-5D46-B232-27D6F6E7F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58A0354-B215-F8EA-7F80-23A2A67FB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0412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F293D2-A967-AA38-6552-8E38BDA54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5E4AD40-6D85-E53F-D680-C1BF2904EB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9E3486B-7872-ECF4-8137-EAD3B51F9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99B514-45A8-23F9-3CFD-92FB13C6E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5DDFEAC-8F11-8901-9FF5-8918838D8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2230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E2F8AFA-2AC2-FDA1-31F9-C5944C262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B66256B-32AD-2ECB-FE62-C9E70E98AD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A3095EB-0DBE-CD08-D028-A5AC2C0BA4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F9CAF1D-216A-92B2-2BED-659820DF3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E52A768-1553-2F76-EB39-53EB58CE8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8019BB5-3E0B-9ADF-D856-463968B1E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0182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9E66D4-D8FA-AD67-79B1-12DA97C7B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8AABCA4-4DC8-1B75-4828-FB076EB89F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FB05C9B-3659-C2FF-DACA-6AAC724689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A773131-2812-8D3B-20AF-1064D9E9B9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1D809D0-AA71-37B9-0247-A8FF87A8D9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F296E3C-E5DF-A7F0-8978-E5E174C4C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9ABE230-0836-E9EF-AA40-D7CCD9552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B14081C-355C-2F64-7F4F-49DD9D049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5737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F3EEFA2-FCCB-AA8A-BF05-DF3DEC837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4A2367A-0A68-5F2F-B514-5F49ED1BF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2155EB1-E481-E75E-8F33-C30250D95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97F01D2-4CD9-A1F1-676A-2247FE6F8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3262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E2714D9-BCD9-A69D-72B8-190C626BC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7108D01-1F39-D315-F1AF-F0FA69D403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735F1A2-E198-5EE0-4CD2-B86895A42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3007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5D09C62-AF4F-0B30-8F51-858402525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74699D1-59C3-9F16-4A73-6915957685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C1AC5F6-41F4-47FD-958E-0337C14005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40C5375-7FAB-22D6-46D9-45045CA6F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1FAC812-50DC-5CB3-71ED-812E18385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0F93EA5-519E-A651-D667-9CBEC940EB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7827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620293B-CF0D-3AA4-C78E-CECBDC8BC9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34D78A1-8B17-E383-4690-4666A7D6E0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FB54EBE-E003-ED90-9F51-C4E9BDE986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844C49A-9463-1178-9B54-A94938E9B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5FCCB6B-0DF6-64DC-9743-4A22BD3DA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52D44AC-B6DB-727F-B1A5-BB55FEC17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9736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9EF4521-43C0-55BB-C88E-D03DAEC579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8FA779F-F671-41D2-3EE6-695FBF866C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7A483F4-3B9B-0627-929E-F17E76A55B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F16496-1F24-4D35-A4D5-5834D81FA995}" type="datetimeFigureOut">
              <a:rPr lang="es-ES" smtClean="0"/>
              <a:t>1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68B60CE-07C2-1CEB-5C5B-4728F4755A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555DE60-2F43-CAF8-FE8A-0D0269B4BA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521E59-3D71-47D6-9574-B023ADA5D0C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2526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uadroTexto 10">
            <a:extLst>
              <a:ext uri="{FF2B5EF4-FFF2-40B4-BE49-F238E27FC236}">
                <a16:creationId xmlns:a16="http://schemas.microsoft.com/office/drawing/2014/main" id="{CE08F9BC-D2E6-ADC1-6071-DF3766FD16D4}"/>
              </a:ext>
            </a:extLst>
          </p:cNvPr>
          <p:cNvSpPr txBox="1"/>
          <p:nvPr/>
        </p:nvSpPr>
        <p:spPr>
          <a:xfrm>
            <a:off x="2275840" y="5577277"/>
            <a:ext cx="7040880" cy="504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.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rticle size distribution by intensity of SS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and SSD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, where the X-axis represents the particle size (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.nm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on a logarithmic scale, and the Y-axis represents the intensity percentage.</a:t>
            </a:r>
            <a:endParaRPr lang="es-ES" sz="16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790DC2E-60F4-7E9B-2B8D-86D9093D750C}"/>
              </a:ext>
            </a:extLst>
          </p:cNvPr>
          <p:cNvGrpSpPr/>
          <p:nvPr/>
        </p:nvGrpSpPr>
        <p:grpSpPr>
          <a:xfrm>
            <a:off x="3083877" y="366077"/>
            <a:ext cx="5069205" cy="5048885"/>
            <a:chOff x="3083877" y="366077"/>
            <a:chExt cx="5069205" cy="5048885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CE51F26-A1B4-9B31-6AAE-DDA65765B890}"/>
                </a:ext>
              </a:extLst>
            </p:cNvPr>
            <p:cNvGrpSpPr/>
            <p:nvPr/>
          </p:nvGrpSpPr>
          <p:grpSpPr>
            <a:xfrm>
              <a:off x="3083877" y="366077"/>
              <a:ext cx="5069205" cy="5048885"/>
              <a:chOff x="3083877" y="366077"/>
              <a:chExt cx="5069205" cy="5048885"/>
            </a:xfrm>
          </p:grpSpPr>
          <p:grpSp>
            <p:nvGrpSpPr>
              <p:cNvPr id="9" name="Grupo 8">
                <a:extLst>
                  <a:ext uri="{FF2B5EF4-FFF2-40B4-BE49-F238E27FC236}">
                    <a16:creationId xmlns:a16="http://schemas.microsoft.com/office/drawing/2014/main" id="{AEE46296-BEA7-D8EE-FFB9-D4B68A5F5894}"/>
                  </a:ext>
                </a:extLst>
              </p:cNvPr>
              <p:cNvGrpSpPr/>
              <p:nvPr/>
            </p:nvGrpSpPr>
            <p:grpSpPr>
              <a:xfrm>
                <a:off x="3083877" y="366077"/>
                <a:ext cx="5069205" cy="5048885"/>
                <a:chOff x="3083877" y="366077"/>
                <a:chExt cx="5069205" cy="5048885"/>
              </a:xfrm>
            </p:grpSpPr>
            <p:pic>
              <p:nvPicPr>
                <p:cNvPr id="6" name="Picture 1">
                  <a:extLst>
                    <a:ext uri="{FF2B5EF4-FFF2-40B4-BE49-F238E27FC236}">
                      <a16:creationId xmlns:a16="http://schemas.microsoft.com/office/drawing/2014/main" id="{670477E8-2F73-86DA-5914-2AD49FE213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083877" y="366077"/>
                  <a:ext cx="5069205" cy="5048885"/>
                </a:xfrm>
                <a:prstGeom prst="rect">
                  <a:avLst/>
                </a:prstGeom>
              </p:spPr>
            </p:pic>
            <p:sp>
              <p:nvSpPr>
                <p:cNvPr id="7" name="CuadroTexto 6">
                  <a:extLst>
                    <a:ext uri="{FF2B5EF4-FFF2-40B4-BE49-F238E27FC236}">
                      <a16:creationId xmlns:a16="http://schemas.microsoft.com/office/drawing/2014/main" id="{7F96EF50-A64B-5BF9-D406-977DA2D8842C}"/>
                    </a:ext>
                  </a:extLst>
                </p:cNvPr>
                <p:cNvSpPr txBox="1"/>
                <p:nvPr/>
              </p:nvSpPr>
              <p:spPr>
                <a:xfrm>
                  <a:off x="3241040" y="558800"/>
                  <a:ext cx="333746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400" dirty="0"/>
                    <a:t>a)</a:t>
                  </a:r>
                </a:p>
              </p:txBody>
            </p:sp>
            <p:sp>
              <p:nvSpPr>
                <p:cNvPr id="8" name="CuadroTexto 7">
                  <a:extLst>
                    <a:ext uri="{FF2B5EF4-FFF2-40B4-BE49-F238E27FC236}">
                      <a16:creationId xmlns:a16="http://schemas.microsoft.com/office/drawing/2014/main" id="{F3BBBBB1-6C7C-7671-B09E-CEA1F3D13E99}"/>
                    </a:ext>
                  </a:extLst>
                </p:cNvPr>
                <p:cNvSpPr txBox="1"/>
                <p:nvPr/>
              </p:nvSpPr>
              <p:spPr>
                <a:xfrm>
                  <a:off x="3241040" y="2705853"/>
                  <a:ext cx="338554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400" dirty="0"/>
                    <a:t>b)</a:t>
                  </a:r>
                </a:p>
              </p:txBody>
            </p:sp>
          </p:grp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C7EC980F-CC67-9CD5-D31C-808D7B55CFD1}"/>
                  </a:ext>
                </a:extLst>
              </p:cNvPr>
              <p:cNvSpPr txBox="1"/>
              <p:nvPr/>
            </p:nvSpPr>
            <p:spPr>
              <a:xfrm>
                <a:off x="3986213" y="2684462"/>
                <a:ext cx="45719" cy="7060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GB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4BE00306-1855-5545-15AC-A42079FF5C69}"/>
                  </a:ext>
                </a:extLst>
              </p:cNvPr>
              <p:cNvSpPr txBox="1"/>
              <p:nvPr/>
            </p:nvSpPr>
            <p:spPr>
              <a:xfrm>
                <a:off x="3969385" y="2547965"/>
                <a:ext cx="4571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.</a:t>
                </a:r>
                <a:endParaRPr lang="en-GB" sz="900" dirty="0"/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F8B4C0A-B634-C13C-CF3C-F739721511F0}"/>
                </a:ext>
              </a:extLst>
            </p:cNvPr>
            <p:cNvSpPr txBox="1"/>
            <p:nvPr/>
          </p:nvSpPr>
          <p:spPr>
            <a:xfrm>
              <a:off x="3990023" y="4933323"/>
              <a:ext cx="45719" cy="706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endParaRPr lang="en-GB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BF53919-BA01-BC9F-79EA-1192ED90D52C}"/>
                </a:ext>
              </a:extLst>
            </p:cNvPr>
            <p:cNvSpPr txBox="1"/>
            <p:nvPr/>
          </p:nvSpPr>
          <p:spPr>
            <a:xfrm>
              <a:off x="3973195" y="4796826"/>
              <a:ext cx="457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.</a:t>
              </a:r>
              <a:endParaRPr lang="en-GB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314082288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4c2a304c-546f-4458-985f-21ede75a2c3b"/>
</p:tagLst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LENA RODRIGUEZ RODRIGUEZ</dc:creator>
  <cp:lastModifiedBy>Angeles Moron Ortiz</cp:lastModifiedBy>
  <cp:revision>1</cp:revision>
  <dcterms:created xsi:type="dcterms:W3CDTF">2025-07-11T07:48:33Z</dcterms:created>
  <dcterms:modified xsi:type="dcterms:W3CDTF">2025-09-12T11:19:26Z</dcterms:modified>
</cp:coreProperties>
</file>